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CB6D41-40AD-45BE-B57B-FD545C288B2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151C8D-A5C2-4F28-A4FF-C33F063501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32C9FD-9C42-4327-9D25-3A50B0EF26C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85F218-B865-4440-A959-BE95284EE2F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5E7F47-473A-4896-AC38-00352F9D60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6B6DEA-3A52-45D3-BFCE-06EBB1359F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EB4A48-AE89-498F-8C30-5BC3FB32E9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688E10-88B5-4F4E-9A1E-8EFF2C8BE3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80F9AB-A1CB-4309-9C91-B81E2427A6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B99455-1812-40F6-8D63-6CA6C8E891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6B9259-4286-4379-9DF0-4DF16A6EF3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0F4C3E-8DA5-4718-9141-B548128FBF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E104FC0-4C60-4330-8C83-B20457FC0BA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87"/>
          <p:cNvGrpSpPr/>
          <p:nvPr/>
        </p:nvGrpSpPr>
        <p:grpSpPr>
          <a:xfrm>
            <a:off x="46080" y="0"/>
            <a:ext cx="9013680" cy="6804000"/>
            <a:chOff x="46080" y="0"/>
            <a:chExt cx="9013680" cy="6804000"/>
          </a:xfrm>
        </p:grpSpPr>
        <p:pic>
          <p:nvPicPr>
            <p:cNvPr id="42" name="Picture 3" descr=""/>
            <p:cNvPicPr/>
            <p:nvPr/>
          </p:nvPicPr>
          <p:blipFill>
            <a:blip r:embed="rId1"/>
            <a:srcRect l="92014" t="0" r="0" b="0"/>
            <a:stretch/>
          </p:blipFill>
          <p:spPr>
            <a:xfrm>
              <a:off x="8906760" y="304560"/>
              <a:ext cx="153000" cy="27432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3" name="Group 13"/>
            <p:cNvGrpSpPr/>
            <p:nvPr/>
          </p:nvGrpSpPr>
          <p:grpSpPr>
            <a:xfrm>
              <a:off x="46080" y="380880"/>
              <a:ext cx="1706040" cy="2590560"/>
              <a:chOff x="46080" y="380880"/>
              <a:chExt cx="1706040" cy="2590560"/>
            </a:xfrm>
          </p:grpSpPr>
          <p:pic>
            <p:nvPicPr>
              <p:cNvPr id="44" name="Picture 3" descr=""/>
              <p:cNvPicPr/>
              <p:nvPr/>
            </p:nvPicPr>
            <p:blipFill>
              <a:blip r:embed="rId2"/>
              <a:srcRect l="0" t="0" r="8478" b="7627"/>
              <a:stretch/>
            </p:blipFill>
            <p:spPr>
              <a:xfrm>
                <a:off x="75960" y="465120"/>
                <a:ext cx="1614960" cy="2506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5" name="Rectangle 8"/>
              <p:cNvSpPr/>
              <p:nvPr/>
            </p:nvSpPr>
            <p:spPr>
              <a:xfrm>
                <a:off x="46080" y="380880"/>
                <a:ext cx="456840" cy="152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TCGA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Rectangle 9"/>
              <p:cNvSpPr/>
              <p:nvPr/>
            </p:nvSpPr>
            <p:spPr>
              <a:xfrm>
                <a:off x="355320" y="387000"/>
                <a:ext cx="446040" cy="120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Le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Rectangle 10"/>
              <p:cNvSpPr/>
              <p:nvPr/>
            </p:nvSpPr>
            <p:spPr>
              <a:xfrm>
                <a:off x="685440" y="380880"/>
                <a:ext cx="446040" cy="118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Mura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Rectangle 11"/>
              <p:cNvSpPr/>
              <p:nvPr/>
            </p:nvSpPr>
            <p:spPr>
              <a:xfrm>
                <a:off x="995040" y="382320"/>
                <a:ext cx="446040" cy="118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Phillips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Rectangle 12"/>
              <p:cNvSpPr/>
              <p:nvPr/>
            </p:nvSpPr>
            <p:spPr>
              <a:xfrm>
                <a:off x="1306080" y="382320"/>
                <a:ext cx="446040" cy="118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Freij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0" name="Group 54"/>
            <p:cNvGrpSpPr/>
            <p:nvPr/>
          </p:nvGrpSpPr>
          <p:grpSpPr>
            <a:xfrm>
              <a:off x="75960" y="0"/>
              <a:ext cx="8686440" cy="243360"/>
              <a:chOff x="75960" y="0"/>
              <a:chExt cx="8686440" cy="243360"/>
            </a:xfrm>
          </p:grpSpPr>
          <p:sp>
            <p:nvSpPr>
              <p:cNvPr id="51" name="Rectangle 27"/>
              <p:cNvSpPr/>
              <p:nvPr/>
            </p:nvSpPr>
            <p:spPr>
              <a:xfrm>
                <a:off x="75960" y="38160"/>
                <a:ext cx="1599840" cy="190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Calibri"/>
                  </a:rPr>
                  <a:t>Iteration #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Rectangle 28"/>
              <p:cNvSpPr/>
              <p:nvPr/>
            </p:nvSpPr>
            <p:spPr>
              <a:xfrm>
                <a:off x="1828440" y="14040"/>
                <a:ext cx="1676160" cy="229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Calibri"/>
                  </a:rPr>
                  <a:t>Iteration #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Rectangle 36"/>
              <p:cNvSpPr/>
              <p:nvPr/>
            </p:nvSpPr>
            <p:spPr>
              <a:xfrm>
                <a:off x="3580920" y="21960"/>
                <a:ext cx="1676160" cy="207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Calibri"/>
                  </a:rPr>
                  <a:t>Iteration #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Rectangle 44"/>
              <p:cNvSpPr/>
              <p:nvPr/>
            </p:nvSpPr>
            <p:spPr>
              <a:xfrm>
                <a:off x="5333400" y="0"/>
                <a:ext cx="1676160" cy="229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Calibri"/>
                  </a:rPr>
                  <a:t>Iteration #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Rectangle 52"/>
              <p:cNvSpPr/>
              <p:nvPr/>
            </p:nvSpPr>
            <p:spPr>
              <a:xfrm>
                <a:off x="7009920" y="0"/>
                <a:ext cx="1752480" cy="229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Calibri"/>
                  </a:rPr>
                  <a:t>Iteration #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56" name="Picture 3" descr=""/>
            <p:cNvPicPr/>
            <p:nvPr/>
          </p:nvPicPr>
          <p:blipFill>
            <a:blip r:embed="rId3"/>
            <a:stretch/>
          </p:blipFill>
          <p:spPr>
            <a:xfrm>
              <a:off x="3657240" y="3299040"/>
              <a:ext cx="2649960" cy="350496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57" name="Straight Arrow Connector 56"/>
            <p:cNvCxnSpPr/>
            <p:nvPr/>
          </p:nvCxnSpPr>
          <p:spPr>
            <a:xfrm>
              <a:off x="3328920" y="5235120"/>
              <a:ext cx="305280" cy="10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58" name="TextBox 57"/>
            <p:cNvSpPr/>
            <p:nvPr/>
          </p:nvSpPr>
          <p:spPr>
            <a:xfrm>
              <a:off x="174600" y="5103720"/>
              <a:ext cx="327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P38 signaling mediated by mapkap kinases pathwa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9" name="Group 63"/>
            <p:cNvGrpSpPr/>
            <p:nvPr/>
          </p:nvGrpSpPr>
          <p:grpSpPr>
            <a:xfrm>
              <a:off x="1837080" y="380880"/>
              <a:ext cx="1706040" cy="2590560"/>
              <a:chOff x="1837080" y="380880"/>
              <a:chExt cx="1706040" cy="2590560"/>
            </a:xfrm>
          </p:grpSpPr>
          <p:pic>
            <p:nvPicPr>
              <p:cNvPr id="60" name="Picture 4" descr=""/>
              <p:cNvPicPr/>
              <p:nvPr/>
            </p:nvPicPr>
            <p:blipFill>
              <a:blip r:embed="rId4"/>
              <a:srcRect l="0" t="0" r="0" b="8041"/>
              <a:stretch/>
            </p:blipFill>
            <p:spPr>
              <a:xfrm>
                <a:off x="1854720" y="464400"/>
                <a:ext cx="1649880" cy="2507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1" name="Rectangle 58"/>
              <p:cNvSpPr/>
              <p:nvPr/>
            </p:nvSpPr>
            <p:spPr>
              <a:xfrm>
                <a:off x="1837080" y="380880"/>
                <a:ext cx="456840" cy="152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TCGA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Rectangle 59"/>
              <p:cNvSpPr/>
              <p:nvPr/>
            </p:nvSpPr>
            <p:spPr>
              <a:xfrm>
                <a:off x="2146320" y="387000"/>
                <a:ext cx="446040" cy="120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Le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Rectangle 60"/>
              <p:cNvSpPr/>
              <p:nvPr/>
            </p:nvSpPr>
            <p:spPr>
              <a:xfrm>
                <a:off x="2476440" y="380880"/>
                <a:ext cx="446040" cy="118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Mura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Rectangle 61"/>
              <p:cNvSpPr/>
              <p:nvPr/>
            </p:nvSpPr>
            <p:spPr>
              <a:xfrm>
                <a:off x="2786040" y="382320"/>
                <a:ext cx="446040" cy="118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Phillips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Rectangle 62"/>
              <p:cNvSpPr/>
              <p:nvPr/>
            </p:nvSpPr>
            <p:spPr>
              <a:xfrm>
                <a:off x="3097080" y="382320"/>
                <a:ext cx="446040" cy="118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Freij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6" name="Group 69"/>
            <p:cNvGrpSpPr/>
            <p:nvPr/>
          </p:nvGrpSpPr>
          <p:grpSpPr>
            <a:xfrm>
              <a:off x="3580560" y="373320"/>
              <a:ext cx="1706760" cy="2598120"/>
              <a:chOff x="3580560" y="373320"/>
              <a:chExt cx="1706760" cy="2598120"/>
            </a:xfrm>
          </p:grpSpPr>
          <p:pic>
            <p:nvPicPr>
              <p:cNvPr id="67" name="Picture 5" descr=""/>
              <p:cNvPicPr/>
              <p:nvPr/>
            </p:nvPicPr>
            <p:blipFill>
              <a:blip r:embed="rId5"/>
              <a:stretch/>
            </p:blipFill>
            <p:spPr>
              <a:xfrm>
                <a:off x="3580920" y="457200"/>
                <a:ext cx="1675800" cy="25142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8" name="Rectangle 64"/>
              <p:cNvSpPr/>
              <p:nvPr/>
            </p:nvSpPr>
            <p:spPr>
              <a:xfrm>
                <a:off x="3580560" y="373320"/>
                <a:ext cx="458280" cy="152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TCGA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Rectangle 65"/>
              <p:cNvSpPr/>
              <p:nvPr/>
            </p:nvSpPr>
            <p:spPr>
              <a:xfrm>
                <a:off x="3889800" y="379440"/>
                <a:ext cx="445680" cy="120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Le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Rectangle 66"/>
              <p:cNvSpPr/>
              <p:nvPr/>
            </p:nvSpPr>
            <p:spPr>
              <a:xfrm>
                <a:off x="4221360" y="373320"/>
                <a:ext cx="445680" cy="118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Mura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Rectangle 67"/>
              <p:cNvSpPr/>
              <p:nvPr/>
            </p:nvSpPr>
            <p:spPr>
              <a:xfrm>
                <a:off x="4530600" y="374760"/>
                <a:ext cx="445680" cy="118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Phillips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Rectangle 68"/>
              <p:cNvSpPr/>
              <p:nvPr/>
            </p:nvSpPr>
            <p:spPr>
              <a:xfrm>
                <a:off x="4841640" y="374760"/>
                <a:ext cx="445680" cy="118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Freij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3" name="Group 75"/>
            <p:cNvGrpSpPr/>
            <p:nvPr/>
          </p:nvGrpSpPr>
          <p:grpSpPr>
            <a:xfrm>
              <a:off x="7077600" y="334440"/>
              <a:ext cx="1706040" cy="2612520"/>
              <a:chOff x="7077600" y="334440"/>
              <a:chExt cx="1706040" cy="2612520"/>
            </a:xfrm>
          </p:grpSpPr>
          <p:pic>
            <p:nvPicPr>
              <p:cNvPr id="74" name="Picture 7" descr=""/>
              <p:cNvPicPr/>
              <p:nvPr/>
            </p:nvPicPr>
            <p:blipFill>
              <a:blip r:embed="rId6"/>
              <a:stretch/>
            </p:blipFill>
            <p:spPr>
              <a:xfrm>
                <a:off x="7106040" y="456480"/>
                <a:ext cx="1656360" cy="24904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5" name="Rectangle 70"/>
              <p:cNvSpPr/>
              <p:nvPr/>
            </p:nvSpPr>
            <p:spPr>
              <a:xfrm>
                <a:off x="7077600" y="334440"/>
                <a:ext cx="456840" cy="152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TCGA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Rectangle 71"/>
              <p:cNvSpPr/>
              <p:nvPr/>
            </p:nvSpPr>
            <p:spPr>
              <a:xfrm>
                <a:off x="7386840" y="340560"/>
                <a:ext cx="446040" cy="120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Le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Rectangle 72"/>
              <p:cNvSpPr/>
              <p:nvPr/>
            </p:nvSpPr>
            <p:spPr>
              <a:xfrm>
                <a:off x="7716960" y="334440"/>
                <a:ext cx="446040" cy="118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Mura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Rectangle 73"/>
              <p:cNvSpPr/>
              <p:nvPr/>
            </p:nvSpPr>
            <p:spPr>
              <a:xfrm>
                <a:off x="8026560" y="335880"/>
                <a:ext cx="446040" cy="118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Phillips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Rectangle 74"/>
              <p:cNvSpPr/>
              <p:nvPr/>
            </p:nvSpPr>
            <p:spPr>
              <a:xfrm>
                <a:off x="8337600" y="335880"/>
                <a:ext cx="446040" cy="118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Freij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0" name="Group 81"/>
            <p:cNvGrpSpPr/>
            <p:nvPr/>
          </p:nvGrpSpPr>
          <p:grpSpPr>
            <a:xfrm>
              <a:off x="5305320" y="312120"/>
              <a:ext cx="1712160" cy="2637000"/>
              <a:chOff x="5305320" y="312120"/>
              <a:chExt cx="1712160" cy="2637000"/>
            </a:xfrm>
          </p:grpSpPr>
          <p:pic>
            <p:nvPicPr>
              <p:cNvPr id="81" name="Picture 6" descr=""/>
              <p:cNvPicPr/>
              <p:nvPr/>
            </p:nvPicPr>
            <p:blipFill>
              <a:blip r:embed="rId7"/>
              <a:stretch/>
            </p:blipFill>
            <p:spPr>
              <a:xfrm>
                <a:off x="5305320" y="380160"/>
                <a:ext cx="1705680" cy="25689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2" name="Rectangle 76"/>
              <p:cNvSpPr/>
              <p:nvPr/>
            </p:nvSpPr>
            <p:spPr>
              <a:xfrm>
                <a:off x="5311800" y="312120"/>
                <a:ext cx="457200" cy="152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TCGA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Rectangle 77"/>
              <p:cNvSpPr/>
              <p:nvPr/>
            </p:nvSpPr>
            <p:spPr>
              <a:xfrm>
                <a:off x="5621400" y="318240"/>
                <a:ext cx="444600" cy="120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Le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Rectangle 78"/>
              <p:cNvSpPr/>
              <p:nvPr/>
            </p:nvSpPr>
            <p:spPr>
              <a:xfrm>
                <a:off x="5951880" y="312120"/>
                <a:ext cx="444600" cy="118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Mura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Rectangle 79"/>
              <p:cNvSpPr/>
              <p:nvPr/>
            </p:nvSpPr>
            <p:spPr>
              <a:xfrm>
                <a:off x="6260040" y="313560"/>
                <a:ext cx="446040" cy="118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Phillips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Rectangle 80"/>
              <p:cNvSpPr/>
              <p:nvPr/>
            </p:nvSpPr>
            <p:spPr>
              <a:xfrm>
                <a:off x="6571440" y="313560"/>
                <a:ext cx="446040" cy="118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</a:rPr>
                  <a:t>Freij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7" name="Rectangle 82"/>
            <p:cNvSpPr/>
            <p:nvPr/>
          </p:nvSpPr>
          <p:spPr>
            <a:xfrm>
              <a:off x="3733920" y="3200400"/>
              <a:ext cx="457200" cy="152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TCG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83"/>
            <p:cNvSpPr/>
            <p:nvPr/>
          </p:nvSpPr>
          <p:spPr>
            <a:xfrm>
              <a:off x="4267080" y="3200400"/>
              <a:ext cx="444240" cy="118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Le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84"/>
            <p:cNvSpPr/>
            <p:nvPr/>
          </p:nvSpPr>
          <p:spPr>
            <a:xfrm>
              <a:off x="4738680" y="3200400"/>
              <a:ext cx="446040" cy="118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Mura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85"/>
            <p:cNvSpPr/>
            <p:nvPr/>
          </p:nvSpPr>
          <p:spPr>
            <a:xfrm>
              <a:off x="5257800" y="3200400"/>
              <a:ext cx="533160" cy="118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Phillip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86"/>
            <p:cNvSpPr/>
            <p:nvPr/>
          </p:nvSpPr>
          <p:spPr>
            <a:xfrm>
              <a:off x="5791320" y="3200400"/>
              <a:ext cx="444240" cy="118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Freij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2" name="Rectangle 88"/>
          <p:cNvSpPr/>
          <p:nvPr/>
        </p:nvSpPr>
        <p:spPr>
          <a:xfrm>
            <a:off x="3657600" y="2986200"/>
            <a:ext cx="26668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Actual Analys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08T15:15:41Z</dcterms:created>
  <dc:creator>rotem</dc:creator>
  <dc:description/>
  <dc:language>en-US</dc:language>
  <cp:lastModifiedBy>EDWA02</cp:lastModifiedBy>
  <dcterms:modified xsi:type="dcterms:W3CDTF">2011-11-28T12:10:59Z</dcterms:modified>
  <cp:revision>13</cp:revision>
  <dc:subject/>
  <dc:title>Slide 1</dc:title>
</cp:coreProperties>
</file>